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F4541-1125-40C7-ABEE-2C3386E85D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7C8ED-0F1B-4C34-B008-8868799565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04860-7CF7-4A00-B1EB-A6CD228BD6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69C08C-F251-496A-94C7-228176E159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C390F7-1E47-48EA-8E5F-3C3EC32607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20F6A9-F1E6-428D-B99F-61EC2BA98B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489B3-0888-4E6B-A380-069FFEB1E6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85F0C-8781-4C53-A4FA-7806EEE655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AEE70-AD3C-4892-AA52-46A325151A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BDB9E-BEE2-4724-B901-E5B6A4AD15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6CE15-BB04-4710-A4B2-19F4B99B93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46816-6C59-4377-9C16-D5A8058298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FB94AD-A800-46AF-8E81-6B4638F24678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0"/>
          <a:ext cx="4572000" cy="2967120"/>
        </p:xfrm>
        <a:graphic>
          <a:graphicData uri="http://schemas.openxmlformats.org/drawingml/2006/table">
            <a:tbl>
              <a:tblPr/>
              <a:tblGrid>
                <a:gridCol w="507960"/>
                <a:gridCol w="507960"/>
                <a:gridCol w="507960"/>
                <a:gridCol w="507960"/>
                <a:gridCol w="508320"/>
                <a:gridCol w="507960"/>
                <a:gridCol w="507960"/>
                <a:gridCol w="507960"/>
                <a:gridCol w="507960"/>
              </a:tblGrid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71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692280" y="395280"/>
          <a:ext cx="5761080" cy="8648640"/>
        </p:xfrm>
        <a:graphic>
          <a:graphicData uri="http://schemas.openxmlformats.org/drawingml/2006/table">
            <a:tbl>
              <a:tblPr/>
              <a:tblGrid>
                <a:gridCol w="720720"/>
                <a:gridCol w="1949400"/>
                <a:gridCol w="571320"/>
                <a:gridCol w="357120"/>
                <a:gridCol w="785880"/>
                <a:gridCol w="728640"/>
                <a:gridCol w="648000"/>
              </a:tblGrid>
              <a:tr h="3650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ngt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r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* detec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AUGGGUGCUGCGCGGUGG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90548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90549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76719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7672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9369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9370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UGUGGUCUCAAAGUGAUA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74000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74001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64903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64906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720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721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CGGUGGAAGGGGCAUGCA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3885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3886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91581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91582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UCAUGCUAUCGUCAGUG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87032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87033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CGGAGGAGGUUAGAGG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15215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15216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CAUUCUCUAUCCGUUAA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0973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0977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6716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66720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AGGGGAUUGGAGGGGCU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03179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03180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26138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26139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32882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32883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21191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21192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39166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39167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24235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24236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 rowSpan="2"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71o/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GAGCCGCGUCAAUAUCU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2010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2011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50084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50085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CUAAAGGUCCAGGAGGCU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0091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0093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9325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9326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GGCUGUGAUGACAAAAAGG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7265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7266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AGGGAAUUGGAGGGGCU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27447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27448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51661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51662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6447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6448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97758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97759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75274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75275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27132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27133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31387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31388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GGUGCAUUGACUUGGUC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19684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19686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AGGCUCGGGGACUACGGU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665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667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CUCCAGGAGUUGAUGGAC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1578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1582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GAAAAGCUAGAACGAUUUA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8588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859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69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AGCCAAGCAUGAUUUGCCC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71739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71740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AUCACAGGAGGAUUGGA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40824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40825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29124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29125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99534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99535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9259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9260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9712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69713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59100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59101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8701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8702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GGAGUGGAUUGAGGGGGC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08255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08256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2622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2623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96803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96804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710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71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GCGGAGAGGCUCUCGAGA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16519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16521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ACUUAGGAACGGAGGGAG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24196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24199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GUGGAUUAGGUGGGAUUG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18342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18343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41359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41360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05729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05730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24286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24287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8426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84262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AUCUCCGACGGCUAGUUA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0169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0170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6000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60002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UCCCCAGCGGAGUCGC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58687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58690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398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CGGGGGCGAACUGAGAA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66267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66269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GGGGAUUGAAGGGGUUA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4662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4663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Rectangle 511"/>
          <p:cNvSpPr/>
          <p:nvPr/>
        </p:nvSpPr>
        <p:spPr>
          <a:xfrm>
            <a:off x="620640" y="90360"/>
            <a:ext cx="583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quences of novel miRNAs identified by small RNA deep sequencing in maiz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333360" y="395280"/>
          <a:ext cx="6120000" cy="6578640"/>
        </p:xfrm>
        <a:graphic>
          <a:graphicData uri="http://schemas.openxmlformats.org/drawingml/2006/table">
            <a:tbl>
              <a:tblPr/>
              <a:tblGrid>
                <a:gridCol w="792000"/>
                <a:gridCol w="2044800"/>
                <a:gridCol w="530280"/>
                <a:gridCol w="455760"/>
                <a:gridCol w="760320"/>
                <a:gridCol w="849240"/>
                <a:gridCol w="687600"/>
              </a:tblGrid>
              <a:tr h="3682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ngt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ar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* detec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AAGUUCGUCGAAAAUAU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0296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0297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UAGCCAAGAAUGGCUUGCC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84609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84611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69t/u/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84203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84205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51934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51936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GAAUUGACGAUUUUGCCCC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5772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5774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UUAAUAAUCUGAAUCCGC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54520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54521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AGAGCUGUUUGCACUGGUG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U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35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35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77170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77171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171q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GAGCCGCGCCAAUAUCUC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7096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7097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GGCCAAUAAGAACUGGU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25465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25467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GCCACGUCGGUAUCCGGU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6544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6546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UGGUCCGUUAGAUCUAGAU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1288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1289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0622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30624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rU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2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3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14887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14888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102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103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9230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9232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36816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36817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59142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59144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9232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9233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8472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8474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9750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79752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67576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67577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48755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48757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AGGAGAUGGGAGUGGCU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88691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88692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AGGGAUUGGAGGGGCU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43700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43700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5724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5725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7425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7426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4799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4800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GGAGGGGAUUGGAGGGGC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05775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05776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AGUCCCUAAAUUGCCGGA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04568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04569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UGGGCGGCAGGGCGAUGGC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3427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3429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GCACCUGCAUACUUUGCUU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9100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9101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GGGCUUUAGCAGUUAACUA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669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670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AGGGGAUUGGAGAGGCU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389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390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25583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25584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58145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58146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17859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17860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UACACAUGGGUUGAGGGA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07051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07052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44422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44423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AGAGGCUGUCAUAUCGA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8712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8713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8494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8495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88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AUGAACCUUGAUUAGCAACA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22864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22867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752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C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UCGUGGGGAUUACAUGCG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91047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91048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5" name="矩形 4"/>
          <p:cNvSpPr/>
          <p:nvPr/>
        </p:nvSpPr>
        <p:spPr>
          <a:xfrm>
            <a:off x="252000" y="119160"/>
            <a:ext cx="130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inu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矩形 3"/>
          <p:cNvSpPr/>
          <p:nvPr/>
        </p:nvSpPr>
        <p:spPr>
          <a:xfrm>
            <a:off x="398880" y="7007400"/>
            <a:ext cx="451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w paralogs of pre-existing miRNA families were cross-referenced and highligh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8T01:11:29Z</dcterms:created>
  <dc:creator>MC SYSTEM</dc:creator>
  <dc:description/>
  <dc:language>en-US</dc:language>
  <cp:lastModifiedBy>MC SYSTEM</cp:lastModifiedBy>
  <dcterms:modified xsi:type="dcterms:W3CDTF">2011-06-24T02:52:22Z</dcterms:modified>
  <cp:revision>38</cp:revision>
  <dc:subject/>
  <dc:title>幻灯片 1</dc:title>
</cp:coreProperties>
</file>